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C8C5D50-D122-42DA-8412-38DE3B7C3C24}" v="1" dt="2025-07-09T19:47:01.409"/>
    <p1510:client id="{80991548-4828-4B0C-8472-EAC2B0178C3A}" v="4" dt="2025-07-09T19:35:46.27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9631B5-78F2-41C9-869B-9F39066F8104}" styleName="Medium Style 3 –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787" y="3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s, Daniel" userId="bd69870e-14b0-4b2a-a293-a297d41864dd" providerId="ADAL" clId="{0C8C5D50-D122-42DA-8412-38DE3B7C3C24}"/>
    <pc:docChg chg="custSel modSld">
      <pc:chgData name="Davids, Daniel" userId="bd69870e-14b0-4b2a-a293-a297d41864dd" providerId="ADAL" clId="{0C8C5D50-D122-42DA-8412-38DE3B7C3C24}" dt="2025-07-09T19:47:05.369" v="2" actId="1076"/>
      <pc:docMkLst>
        <pc:docMk/>
      </pc:docMkLst>
      <pc:sldChg chg="addSp delSp modSp mod">
        <pc:chgData name="Davids, Daniel" userId="bd69870e-14b0-4b2a-a293-a297d41864dd" providerId="ADAL" clId="{0C8C5D50-D122-42DA-8412-38DE3B7C3C24}" dt="2025-07-09T19:47:05.369" v="2" actId="1076"/>
        <pc:sldMkLst>
          <pc:docMk/>
          <pc:sldMk cId="174092475" sldId="257"/>
        </pc:sldMkLst>
        <pc:graphicFrameChg chg="add mod">
          <ac:chgData name="Davids, Daniel" userId="bd69870e-14b0-4b2a-a293-a297d41864dd" providerId="ADAL" clId="{0C8C5D50-D122-42DA-8412-38DE3B7C3C24}" dt="2025-07-09T19:47:05.369" v="2" actId="1076"/>
          <ac:graphicFrameMkLst>
            <pc:docMk/>
            <pc:sldMk cId="174092475" sldId="257"/>
            <ac:graphicFrameMk id="2" creationId="{1F7203CD-9F61-8233-22F2-49DFA9FB0EF4}"/>
          </ac:graphicFrameMkLst>
        </pc:graphicFrameChg>
        <pc:graphicFrameChg chg="del">
          <ac:chgData name="Davids, Daniel" userId="bd69870e-14b0-4b2a-a293-a297d41864dd" providerId="ADAL" clId="{0C8C5D50-D122-42DA-8412-38DE3B7C3C24}" dt="2025-07-09T19:46:51.478" v="0" actId="478"/>
          <ac:graphicFrameMkLst>
            <pc:docMk/>
            <pc:sldMk cId="174092475" sldId="257"/>
            <ac:graphicFrameMk id="4" creationId="{E0B12A61-35CD-6C46-A602-47E37FE98DF0}"/>
          </ac:graphicFrameMkLst>
        </pc:graphicFrameChg>
      </pc:sldChg>
    </pc:docChg>
  </pc:docChgLst>
  <pc:docChgLst>
    <pc:chgData name="Davids, Daniel" userId="bd69870e-14b0-4b2a-a293-a297d41864dd" providerId="ADAL" clId="{F360EA8D-2CEF-44DC-A095-62624361F870}"/>
    <pc:docChg chg="custSel addSld modSld">
      <pc:chgData name="Davids, Daniel" userId="bd69870e-14b0-4b2a-a293-a297d41864dd" providerId="ADAL" clId="{F360EA8D-2CEF-44DC-A095-62624361F870}" dt="2024-11-03T19:02:12.238" v="30" actId="1035"/>
      <pc:docMkLst>
        <pc:docMk/>
      </pc:docMkLst>
      <pc:sldChg chg="addSp delSp modSp mod">
        <pc:chgData name="Davids, Daniel" userId="bd69870e-14b0-4b2a-a293-a297d41864dd" providerId="ADAL" clId="{F360EA8D-2CEF-44DC-A095-62624361F870}" dt="2024-11-03T19:02:12.238" v="30" actId="1035"/>
        <pc:sldMkLst>
          <pc:docMk/>
          <pc:sldMk cId="174092475" sldId="257"/>
        </pc:sldMkLst>
      </pc:sldChg>
      <pc:sldChg chg="delSp modSp add mod">
        <pc:chgData name="Davids, Daniel" userId="bd69870e-14b0-4b2a-a293-a297d41864dd" providerId="ADAL" clId="{F360EA8D-2CEF-44DC-A095-62624361F870}" dt="2024-11-03T18:56:55.974" v="23" actId="20577"/>
        <pc:sldMkLst>
          <pc:docMk/>
          <pc:sldMk cId="3475097194" sldId="258"/>
        </pc:sldMkLst>
      </pc:sldChg>
    </pc:docChg>
  </pc:docChgLst>
  <pc:docChgLst>
    <pc:chgData name="Davids, Daniel" userId="bd69870e-14b0-4b2a-a293-a297d41864dd" providerId="ADAL" clId="{6A553EA6-244C-48F8-95FD-828D1717A47C}"/>
    <pc:docChg chg="custSel addSld delSld modSld">
      <pc:chgData name="Davids, Daniel" userId="bd69870e-14b0-4b2a-a293-a297d41864dd" providerId="ADAL" clId="{6A553EA6-244C-48F8-95FD-828D1717A47C}" dt="2025-03-05T23:50:11.992" v="16" actId="1076"/>
      <pc:docMkLst>
        <pc:docMk/>
      </pc:docMkLst>
      <pc:sldChg chg="addSp delSp modSp mod">
        <pc:chgData name="Davids, Daniel" userId="bd69870e-14b0-4b2a-a293-a297d41864dd" providerId="ADAL" clId="{6A553EA6-244C-48F8-95FD-828D1717A47C}" dt="2025-03-05T23:50:11.992" v="16" actId="1076"/>
        <pc:sldMkLst>
          <pc:docMk/>
          <pc:sldMk cId="174092475" sldId="257"/>
        </pc:sldMkLst>
      </pc:sldChg>
      <pc:sldChg chg="del">
        <pc:chgData name="Davids, Daniel" userId="bd69870e-14b0-4b2a-a293-a297d41864dd" providerId="ADAL" clId="{6A553EA6-244C-48F8-95FD-828D1717A47C}" dt="2025-03-05T21:20:23.750" v="3" actId="47"/>
        <pc:sldMkLst>
          <pc:docMk/>
          <pc:sldMk cId="3475097194" sldId="258"/>
        </pc:sldMkLst>
      </pc:sldChg>
      <pc:sldChg chg="add del">
        <pc:chgData name="Davids, Daniel" userId="bd69870e-14b0-4b2a-a293-a297d41864dd" providerId="ADAL" clId="{6A553EA6-244C-48F8-95FD-828D1717A47C}" dt="2025-03-05T21:20:16.677" v="2" actId="47"/>
        <pc:sldMkLst>
          <pc:docMk/>
          <pc:sldMk cId="4035310119" sldId="259"/>
        </pc:sldMkLst>
      </pc:sldChg>
      <pc:sldChg chg="add del">
        <pc:chgData name="Davids, Daniel" userId="bd69870e-14b0-4b2a-a293-a297d41864dd" providerId="ADAL" clId="{6A553EA6-244C-48F8-95FD-828D1717A47C}" dt="2025-03-05T21:20:16.677" v="2" actId="47"/>
        <pc:sldMkLst>
          <pc:docMk/>
          <pc:sldMk cId="3572187018" sldId="260"/>
        </pc:sldMkLst>
      </pc:sldChg>
    </pc:docChg>
  </pc:docChgLst>
  <pc:docChgLst>
    <pc:chgData name="Davids, Daniel" userId="bd69870e-14b0-4b2a-a293-a297d41864dd" providerId="ADAL" clId="{B0D606D2-1008-41BC-A72F-F713ABC021F4}"/>
    <pc:docChg chg="addSld delSld modSld">
      <pc:chgData name="Davids, Daniel" userId="bd69870e-14b0-4b2a-a293-a297d41864dd" providerId="ADAL" clId="{B0D606D2-1008-41BC-A72F-F713ABC021F4}" dt="2024-11-03T18:32:44.267" v="35" actId="47"/>
      <pc:docMkLst>
        <pc:docMk/>
      </pc:docMkLst>
      <pc:sldChg chg="new del">
        <pc:chgData name="Davids, Daniel" userId="bd69870e-14b0-4b2a-a293-a297d41864dd" providerId="ADAL" clId="{B0D606D2-1008-41BC-A72F-F713ABC021F4}" dt="2024-11-03T18:19:33.782" v="2" actId="47"/>
        <pc:sldMkLst>
          <pc:docMk/>
          <pc:sldMk cId="2106742275" sldId="256"/>
        </pc:sldMkLst>
      </pc:sldChg>
      <pc:sldChg chg="addSp delSp modSp new mod">
        <pc:chgData name="Davids, Daniel" userId="bd69870e-14b0-4b2a-a293-a297d41864dd" providerId="ADAL" clId="{B0D606D2-1008-41BC-A72F-F713ABC021F4}" dt="2024-11-03T18:31:45.297" v="32" actId="14100"/>
        <pc:sldMkLst>
          <pc:docMk/>
          <pc:sldMk cId="174092475" sldId="257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261132528" sldId="258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129412391" sldId="259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459212972" sldId="260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083949308" sldId="261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847408672" sldId="262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110391834" sldId="263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546292502" sldId="264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035228439" sldId="265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1002150119" sldId="266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2056411075" sldId="267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923372120" sldId="268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752528510" sldId="269"/>
        </pc:sldMkLst>
      </pc:sldChg>
      <pc:sldChg chg="add del">
        <pc:chgData name="Davids, Daniel" userId="bd69870e-14b0-4b2a-a293-a297d41864dd" providerId="ADAL" clId="{B0D606D2-1008-41BC-A72F-F713ABC021F4}" dt="2024-11-03T18:32:35.079" v="34" actId="47"/>
        <pc:sldMkLst>
          <pc:docMk/>
          <pc:sldMk cId="2664668440" sldId="270"/>
        </pc:sldMkLst>
      </pc:sldChg>
      <pc:sldChg chg="add del">
        <pc:chgData name="Davids, Daniel" userId="bd69870e-14b0-4b2a-a293-a297d41864dd" providerId="ADAL" clId="{B0D606D2-1008-41BC-A72F-F713ABC021F4}" dt="2024-11-03T18:32:35.079" v="34" actId="47"/>
        <pc:sldMkLst>
          <pc:docMk/>
          <pc:sldMk cId="107856901" sldId="271"/>
        </pc:sldMkLst>
      </pc:sldChg>
      <pc:sldChg chg="add del">
        <pc:chgData name="Davids, Daniel" userId="bd69870e-14b0-4b2a-a293-a297d41864dd" providerId="ADAL" clId="{B0D606D2-1008-41BC-A72F-F713ABC021F4}" dt="2024-11-03T18:32:32.890" v="33" actId="47"/>
        <pc:sldMkLst>
          <pc:docMk/>
          <pc:sldMk cId="1885141936" sldId="272"/>
        </pc:sldMkLst>
      </pc:sldChg>
    </pc:docChg>
  </pc:docChgLst>
  <pc:docChgLst>
    <pc:chgData name="Davids, Daniel" userId="bd69870e-14b0-4b2a-a293-a297d41864dd" providerId="ADAL" clId="{80991548-4828-4B0C-8472-EAC2B0178C3A}"/>
    <pc:docChg chg="custSel modSld">
      <pc:chgData name="Davids, Daniel" userId="bd69870e-14b0-4b2a-a293-a297d41864dd" providerId="ADAL" clId="{80991548-4828-4B0C-8472-EAC2B0178C3A}" dt="2025-07-09T19:35:53.748" v="3" actId="1076"/>
      <pc:docMkLst>
        <pc:docMk/>
      </pc:docMkLst>
      <pc:sldChg chg="addSp delSp modSp mod">
        <pc:chgData name="Davids, Daniel" userId="bd69870e-14b0-4b2a-a293-a297d41864dd" providerId="ADAL" clId="{80991548-4828-4B0C-8472-EAC2B0178C3A}" dt="2025-07-09T19:35:53.748" v="3" actId="1076"/>
        <pc:sldMkLst>
          <pc:docMk/>
          <pc:sldMk cId="174092475" sldId="257"/>
        </pc:sldMkLst>
        <pc:graphicFrameChg chg="add mod">
          <ac:chgData name="Davids, Daniel" userId="bd69870e-14b0-4b2a-a293-a297d41864dd" providerId="ADAL" clId="{80991548-4828-4B0C-8472-EAC2B0178C3A}" dt="2025-07-09T19:35:38.190" v="1"/>
          <ac:graphicFrameMkLst>
            <pc:docMk/>
            <pc:sldMk cId="174092475" sldId="257"/>
            <ac:graphicFrameMk id="2" creationId="{E32B4A51-178D-C890-AB83-2FB66FFC672E}"/>
          </ac:graphicFrameMkLst>
        </pc:graphicFrameChg>
        <pc:graphicFrameChg chg="del">
          <ac:chgData name="Davids, Daniel" userId="bd69870e-14b0-4b2a-a293-a297d41864dd" providerId="ADAL" clId="{80991548-4828-4B0C-8472-EAC2B0178C3A}" dt="2025-07-09T19:33:30.622" v="0" actId="478"/>
          <ac:graphicFrameMkLst>
            <pc:docMk/>
            <pc:sldMk cId="174092475" sldId="257"/>
            <ac:graphicFrameMk id="3" creationId="{628EA2F4-7C09-610F-3DE6-012586300E54}"/>
          </ac:graphicFrameMkLst>
        </pc:graphicFrameChg>
        <pc:graphicFrameChg chg="add mod">
          <ac:chgData name="Davids, Daniel" userId="bd69870e-14b0-4b2a-a293-a297d41864dd" providerId="ADAL" clId="{80991548-4828-4B0C-8472-EAC2B0178C3A}" dt="2025-07-09T19:35:53.748" v="3" actId="1076"/>
          <ac:graphicFrameMkLst>
            <pc:docMk/>
            <pc:sldMk cId="174092475" sldId="257"/>
            <ac:graphicFrameMk id="4" creationId="{E0B12A61-35CD-6C46-A602-47E37FE98DF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468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7609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9197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026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6569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024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790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5091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280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5677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2295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1966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F7203CD-9F61-8233-22F2-49DFA9FB0E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3596515"/>
              </p:ext>
            </p:extLst>
          </p:nvPr>
        </p:nvGraphicFramePr>
        <p:xfrm>
          <a:off x="1631950" y="1965960"/>
          <a:ext cx="8928100" cy="1463040"/>
        </p:xfrm>
        <a:graphic>
          <a:graphicData uri="http://schemas.openxmlformats.org/drawingml/2006/table">
            <a:tbl>
              <a:tblPr firstRow="1" firstCol="1" bandRow="1"/>
              <a:tblGrid>
                <a:gridCol w="1710690">
                  <a:extLst>
                    <a:ext uri="{9D8B030D-6E8A-4147-A177-3AD203B41FA5}">
                      <a16:colId xmlns:a16="http://schemas.microsoft.com/office/drawing/2014/main" val="554654910"/>
                    </a:ext>
                  </a:extLst>
                </a:gridCol>
                <a:gridCol w="1604010">
                  <a:extLst>
                    <a:ext uri="{9D8B030D-6E8A-4147-A177-3AD203B41FA5}">
                      <a16:colId xmlns:a16="http://schemas.microsoft.com/office/drawing/2014/main" val="2396566626"/>
                    </a:ext>
                  </a:extLst>
                </a:gridCol>
                <a:gridCol w="1384300">
                  <a:extLst>
                    <a:ext uri="{9D8B030D-6E8A-4147-A177-3AD203B41FA5}">
                      <a16:colId xmlns:a16="http://schemas.microsoft.com/office/drawing/2014/main" val="116451230"/>
                    </a:ext>
                  </a:extLst>
                </a:gridCol>
                <a:gridCol w="1384300">
                  <a:extLst>
                    <a:ext uri="{9D8B030D-6E8A-4147-A177-3AD203B41FA5}">
                      <a16:colId xmlns:a16="http://schemas.microsoft.com/office/drawing/2014/main" val="376001510"/>
                    </a:ext>
                  </a:extLst>
                </a:gridCol>
                <a:gridCol w="1460500">
                  <a:extLst>
                    <a:ext uri="{9D8B030D-6E8A-4147-A177-3AD203B41FA5}">
                      <a16:colId xmlns:a16="http://schemas.microsoft.com/office/drawing/2014/main" val="2763945495"/>
                    </a:ext>
                  </a:extLst>
                </a:gridCol>
                <a:gridCol w="1384300">
                  <a:extLst>
                    <a:ext uri="{9D8B030D-6E8A-4147-A177-3AD203B41FA5}">
                      <a16:colId xmlns:a16="http://schemas.microsoft.com/office/drawing/2014/main" val="2518451020"/>
                    </a:ext>
                  </a:extLst>
                </a:gridCol>
              </a:tblGrid>
              <a:tr h="182880"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y = Intercept + B1*x^1 + B2*x^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280007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lo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25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5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03109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tercep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16884 ± 0.0132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33179 ± 0.0131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37462 ± 0.0427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1862 ± 0.0132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5343 ± 0.0103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565985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27264 ± 0.2468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.23386 ± 0.1272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70956 ± 0.2554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44414 ± 0.0574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20302 ± 0.0291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320927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8.78528 ± 1.0076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8.02689 ± 0.294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4.82178 ± 0.3750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2.41543 ± 0.0616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80156 ± 0.0203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118922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sidual Sum of Square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.82E-0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.55E-0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22E-0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31E-0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60E-0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933007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-Square (COD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2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8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3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9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8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016651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. R-Squar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77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6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79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7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67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03571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4092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119</Words>
  <Application>Microsoft Office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vids, Daniel</dc:creator>
  <cp:lastModifiedBy>Davids, Daniel</cp:lastModifiedBy>
  <cp:revision>1</cp:revision>
  <dcterms:created xsi:type="dcterms:W3CDTF">2024-11-03T18:19:26Z</dcterms:created>
  <dcterms:modified xsi:type="dcterms:W3CDTF">2025-07-09T19:47:05Z</dcterms:modified>
</cp:coreProperties>
</file>